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  <p:sldId id="265" r:id="rId3"/>
    <p:sldId id="262" r:id="rId4"/>
    <p:sldId id="261" r:id="rId5"/>
    <p:sldId id="263" r:id="rId6"/>
    <p:sldId id="260" r:id="rId7"/>
    <p:sldId id="259" r:id="rId8"/>
    <p:sldId id="257" r:id="rId9"/>
    <p:sldId id="256" r:id="rId10"/>
    <p:sldId id="264" r:id="rId11"/>
    <p:sldId id="258" r:id="rId12"/>
  </p:sldIdLst>
  <p:sldSz cx="12192000" cy="6858000"/>
  <p:notesSz cx="6858000" cy="9144000"/>
  <p:defaultTextStyle>
    <a:defPPr>
      <a:defRPr lang="en-TH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551"/>
    <p:restoredTop sz="94717"/>
  </p:normalViewPr>
  <p:slideViewPr>
    <p:cSldViewPr snapToGrid="0" snapToObjects="1">
      <p:cViewPr varScale="1">
        <p:scale>
          <a:sx n="107" d="100"/>
          <a:sy n="107" d="100"/>
        </p:scale>
        <p:origin x="680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922BE1-CA8F-1044-A9CB-45A1288C78C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6BF010D-D3DD-B247-BEB2-9E27F27159E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136523-A200-9C4A-A674-2161BA2227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5FB5F-D3BB-574B-BCEF-8D82C862D70B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4C8C75-F261-9B40-AC8F-2E96EC8056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16FCCA-2E9F-744B-BDFE-273567168F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C18E97-499C-FB40-A531-F52348C7EBD4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3334046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A558A3-650C-6142-901D-58FE03C74E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73D955-FCE2-044D-B03F-8176AEAAFD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FE909B-8CE6-8A4C-B63D-C127D12F1A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5FB5F-D3BB-574B-BCEF-8D82C862D70B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C8D973-A1F2-164F-98D4-321823F5DD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BCED45-F34A-F043-892B-BB4EA73762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C18E97-499C-FB40-A531-F52348C7EBD4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4262547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6112B25-B200-9E4B-B4E0-0A4559C6341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9ADD07-02BC-6F4B-9793-F586673E2C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CE4A10-CFF1-5F45-B263-8A2B33512D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5FB5F-D3BB-574B-BCEF-8D82C862D70B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CD08A5-F160-CE47-B751-ABF035DD74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0B7898-B2F0-9C46-A1CF-EE4B3C3C04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C18E97-499C-FB40-A531-F52348C7EBD4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855100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4E994B-4D4B-214A-9C64-D5E14EA7C9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59E140-2DBB-E547-85DA-FBB45A47390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A21DE6-0D8E-F34B-AC79-74DC66B6F1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5FB5F-D3BB-574B-BCEF-8D82C862D70B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6CFCE5-8FB2-E449-9023-284D066BDD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6B5249-B034-CC44-A23A-56A65AADE3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C18E97-499C-FB40-A531-F52348C7EBD4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598597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B3C70D-969A-0E44-9467-B09E7EA32E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2D674C-F88B-E846-A6E6-A1E563F7F6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F600A1-BA7B-D24C-BC95-2293CA3BC2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5FB5F-D3BB-574B-BCEF-8D82C862D70B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817BCD-2C2C-9943-A394-C19A88E9C7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763F6A-A81A-9A40-983C-7AF09D6404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C18E97-499C-FB40-A531-F52348C7EBD4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5367814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296577-20EE-BF43-B5FE-A6C2EF8D01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668080-C763-BC47-97B8-457F244C30E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A2630D1-FCB5-4243-87F7-0D4E9E4962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AEB3F4-C43E-6D43-A829-AC25604315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5FB5F-D3BB-574B-BCEF-8D82C862D70B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E4AA61-EF47-9F46-B748-B6291A00CD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5F851F-C0F3-5243-890F-D6DF14EAA7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C18E97-499C-FB40-A531-F52348C7EBD4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0545842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D68CE3-295C-EC4D-95B2-AF5639870E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A8CBB8-04BF-C647-8322-97353FEA81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0B90F73-B349-E84A-B1B1-6147D782D9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4A6E380-1227-2847-B957-36DE596260C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0D0E171-C070-4C4B-BD5C-9C66FBAFA4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4BA5E23-F91C-8442-BA47-BC11462076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5FB5F-D3BB-574B-BCEF-8D82C862D70B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206012D-D855-814C-A2DB-3CD9B1DDEF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5A08B99-80B6-384F-95AB-D5F3A5E18F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C18E97-499C-FB40-A531-F52348C7EBD4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8974159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1D9A90-1B69-1647-8075-1B78BF2FEC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BA6C881-AF91-664F-96BD-CF61190DA8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5FB5F-D3BB-574B-BCEF-8D82C862D70B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9461DD8-6B4A-C047-A1A7-84F8D5D55A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A4768DF-877B-A844-85FA-948AE1BD2F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C18E97-499C-FB40-A531-F52348C7EBD4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228664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DBACC2A-0048-0F40-A780-1B0E18557E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5FB5F-D3BB-574B-BCEF-8D82C862D70B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3123778-13B6-C04A-BB01-D960DF0AC9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CCAD09B-340D-0442-99EB-1B0E58B8B1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C18E97-499C-FB40-A531-F52348C7EBD4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4402522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64971E-2C8B-FE42-913C-DDC8ABDA3C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8725939-2164-AF42-A9B0-E234FCBA4C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D5105A-E80A-A74E-92FC-E68CE518DE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E715CF-9CEF-DA4A-B2AB-23B8A680E0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5FB5F-D3BB-574B-BCEF-8D82C862D70B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C35F170-1680-E54A-ACEC-51977BCA43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FB7162-6E71-2842-AABB-1BD5625C28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C18E97-499C-FB40-A531-F52348C7EBD4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081236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D94996-6981-D84E-A4B3-9291DD243F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ACAAA71-40F4-FB4B-AD32-C92BC9570F1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T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9F72232-3D86-2F4C-BEE4-F8C4348ADA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ADE218-4053-AB4B-9783-B1D41720E1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5FB5F-D3BB-574B-BCEF-8D82C862D70B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A91144-6265-B041-B803-726EC5A010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FF8131-36CB-5945-9283-57E60BC735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C18E97-499C-FB40-A531-F52348C7EBD4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272657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DA90303-4464-F847-9C84-7D5252675F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4C7A4A-0FE0-5746-824E-9EEA1C1221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F72A6C-EF25-2349-A884-6D16D57876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C5FB5F-D3BB-574B-BCEF-8D82C862D70B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735C1D-BFE0-DF4A-8F48-BA475E7FAB2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D43DF0-F53E-9140-A74D-713A61FD286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C18E97-499C-FB40-A531-F52348C7EBD4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0213077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TH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3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6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4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7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2">
            <a:extLst>
              <a:ext uri="{FF2B5EF4-FFF2-40B4-BE49-F238E27FC236}">
                <a16:creationId xmlns:a16="http://schemas.microsoft.com/office/drawing/2014/main" id="{9AAA80DA-2AAE-6E4A-FB96-1811718884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0" y="923100"/>
            <a:ext cx="12192000" cy="4351338"/>
          </a:xfrm>
        </p:spPr>
        <p:txBody>
          <a:bodyPr/>
          <a:lstStyle/>
          <a:p>
            <a:pPr marL="0" indent="0" algn="ctr">
              <a:lnSpc>
                <a:spcPct val="200000"/>
              </a:lnSpc>
              <a:buNone/>
            </a:pP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 algn="ctr">
              <a:lnSpc>
                <a:spcPct val="200000"/>
              </a:lnSpc>
              <a:buNone/>
            </a:pP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</a:t>
            </a:r>
            <a:r>
              <a:rPr lang="en-US" b="1">
                <a:latin typeface="Times New Roman" panose="02020603050405020304" pitchFamily="18" charset="0"/>
                <a:cs typeface="Times New Roman" panose="02020603050405020304" pitchFamily="18" charset="0"/>
              </a:rPr>
              <a:t>file 6: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 algn="ctr">
              <a:lnSpc>
                <a:spcPct val="200000"/>
              </a:lnSpc>
              <a:buNone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quality assessment of RNA-sequencing</a:t>
            </a:r>
          </a:p>
        </p:txBody>
      </p:sp>
    </p:spTree>
    <p:extLst>
      <p:ext uri="{BB962C8B-B14F-4D97-AF65-F5344CB8AC3E}">
        <p14:creationId xmlns:p14="http://schemas.microsoft.com/office/powerpoint/2010/main" val="402257285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C3E09796-7760-849A-6C8B-0D130BC63A12}"/>
              </a:ext>
            </a:extLst>
          </p:cNvPr>
          <p:cNvGrpSpPr/>
          <p:nvPr/>
        </p:nvGrpSpPr>
        <p:grpSpPr>
          <a:xfrm>
            <a:off x="307163" y="1629000"/>
            <a:ext cx="11577674" cy="3600000"/>
            <a:chOff x="307163" y="1629000"/>
            <a:chExt cx="11577674" cy="36000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33ABA2CB-5655-9749-B029-2080D83B018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07163" y="1629000"/>
              <a:ext cx="3600000" cy="360000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B512F959-F3EE-2D4D-9833-665F4170BA4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96000" y="1629000"/>
              <a:ext cx="3600000" cy="36000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89BB901C-8E61-4244-A657-5F5DAB16D41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284837" y="1629000"/>
              <a:ext cx="3600000" cy="3600000"/>
            </a:xfrm>
            <a:prstGeom prst="rect">
              <a:avLst/>
            </a:prstGeom>
          </p:spPr>
        </p:pic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D2536718-7A43-65B1-FBF5-71F79BB0E937}"/>
              </a:ext>
            </a:extLst>
          </p:cNvPr>
          <p:cNvSpPr txBox="1"/>
          <p:nvPr/>
        </p:nvSpPr>
        <p:spPr>
          <a:xfrm>
            <a:off x="0" y="440976"/>
            <a:ext cx="1219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the Ut tissue samples </a:t>
            </a:r>
            <a:endParaRPr lang="en-TH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A6AFBC3-99D9-EA3F-BD28-C9FC78E537B0}"/>
              </a:ext>
            </a:extLst>
          </p:cNvPr>
          <p:cNvSpPr txBox="1"/>
          <p:nvPr/>
        </p:nvSpPr>
        <p:spPr>
          <a:xfrm>
            <a:off x="858981" y="5524472"/>
            <a:ext cx="107907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male tissue samples include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he germinal zone of the ovary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v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ovary, part of oviduct; Ut: uterus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f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female somatic tissues. </a:t>
            </a:r>
            <a:endParaRPr lang="en-TH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6834398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31EFC037-A5EE-1D3A-D525-628BD0D74DF6}"/>
              </a:ext>
            </a:extLst>
          </p:cNvPr>
          <p:cNvGrpSpPr/>
          <p:nvPr/>
        </p:nvGrpSpPr>
        <p:grpSpPr>
          <a:xfrm>
            <a:off x="456931" y="1617736"/>
            <a:ext cx="11400678" cy="3611264"/>
            <a:chOff x="456931" y="1617736"/>
            <a:chExt cx="11400678" cy="3611264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44074B15-AF09-1A46-A0AD-942AD41079F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56931" y="1629000"/>
              <a:ext cx="3600000" cy="360000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BDFBBB77-FC12-1A47-A8C4-2EC108CDD8F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96000" y="1629000"/>
              <a:ext cx="3600000" cy="36000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FC95B55E-827E-5046-8098-7EA0216D5E3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257609" y="1617736"/>
              <a:ext cx="3600000" cy="3600000"/>
            </a:xfrm>
            <a:prstGeom prst="rect">
              <a:avLst/>
            </a:prstGeom>
          </p:spPr>
        </p:pic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61C88FD9-55A2-3D57-3286-9178F33A294D}"/>
              </a:ext>
            </a:extLst>
          </p:cNvPr>
          <p:cNvSpPr txBox="1"/>
          <p:nvPr/>
        </p:nvSpPr>
        <p:spPr>
          <a:xfrm>
            <a:off x="0" y="440976"/>
            <a:ext cx="1219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the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f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ssue samples </a:t>
            </a:r>
            <a:endParaRPr lang="en-TH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02CE272-E3DC-F3B3-0F37-FD65EF69E697}"/>
              </a:ext>
            </a:extLst>
          </p:cNvPr>
          <p:cNvSpPr txBox="1"/>
          <p:nvPr/>
        </p:nvSpPr>
        <p:spPr>
          <a:xfrm>
            <a:off x="858981" y="5524472"/>
            <a:ext cx="107907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male tissue samples include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he germinal zone of the ovary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v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ovary, part of oviduct; Ut: uterus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f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female somatic tissues. </a:t>
            </a:r>
            <a:endParaRPr lang="en-TH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18605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E86A5BB-BA88-F14D-8F49-DC65F476EC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26803" y="649155"/>
            <a:ext cx="5181628" cy="518162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191043E-67EA-948E-B682-FE955DFFD95A}"/>
              </a:ext>
            </a:extLst>
          </p:cNvPr>
          <p:cNvSpPr txBox="1"/>
          <p:nvPr/>
        </p:nvSpPr>
        <p:spPr>
          <a:xfrm>
            <a:off x="0" y="154256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 Sample relationships revealed by RNA-Seq correlation examination</a:t>
            </a:r>
            <a:r>
              <a:rPr lang="en-TH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sing P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rson’s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rrelation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7171746-079E-6EEA-219E-85DAFAD2F369}"/>
              </a:ext>
            </a:extLst>
          </p:cNvPr>
          <p:cNvSpPr txBox="1"/>
          <p:nvPr/>
        </p:nvSpPr>
        <p:spPr>
          <a:xfrm>
            <a:off x="1464622" y="5830782"/>
            <a:ext cx="967443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thaiDi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le tissue samples include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he germinal zone of the testis; Tv: testis, part of vas deferens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v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seminal vesicle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male somatic tissues. Female tissue samples include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he germinal zone of the ovary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v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ovary, part of oviduct; Ut: uterus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f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female somatic tissues. Three biological replicates of each male and female tissue type were analyzed in this study, with each replicate from a worm derived from a different participant.</a:t>
            </a:r>
            <a:r>
              <a:rPr lang="en-TH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3148651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F7580FB-F19A-2C44-A578-45CD2F0FB5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79765" y="784776"/>
            <a:ext cx="6173912" cy="493913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5EE319C-8CC2-2249-A5B9-F65C41C7A4D4}"/>
              </a:ext>
            </a:extLst>
          </p:cNvPr>
          <p:cNvSpPr txBox="1"/>
          <p:nvPr/>
        </p:nvSpPr>
        <p:spPr>
          <a:xfrm>
            <a:off x="0" y="197829"/>
            <a:ext cx="1219199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mple relationships revealed by </a:t>
            </a:r>
            <a:r>
              <a:rPr lang="en-US" b="1" i="0" u="none" strike="noStrike" dirty="0">
                <a:solidFill>
                  <a:srgbClr val="333333"/>
                </a:solidFill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PCA (Principal Component Analysis) </a:t>
            </a:r>
            <a:endParaRPr lang="en-TH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74CB403-CD38-4CB8-536C-607EDF6CA6AC}"/>
              </a:ext>
            </a:extLst>
          </p:cNvPr>
          <p:cNvSpPr txBox="1"/>
          <p:nvPr/>
        </p:nvSpPr>
        <p:spPr>
          <a:xfrm>
            <a:off x="1464622" y="5807032"/>
            <a:ext cx="967443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thaiDi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le tissue samples include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he germinal zone of the testis; Tv: testis, part of vas deferens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v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seminal vesicle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male somatic tissues. Female tissue samples include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he germinal zone of the ovary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v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ovary, part of oviduct; Ut: uterus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f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female somatic tissues. Three biological replicates of each male and female tissue type were analyzed in this study, with each replicate from a worm derived from a different participant.</a:t>
            </a:r>
            <a:r>
              <a:rPr lang="en-TH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9968597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8E1AFF8F-AF36-E47C-AAA2-6EE33509807D}"/>
              </a:ext>
            </a:extLst>
          </p:cNvPr>
          <p:cNvGrpSpPr/>
          <p:nvPr/>
        </p:nvGrpSpPr>
        <p:grpSpPr>
          <a:xfrm>
            <a:off x="407070" y="1629000"/>
            <a:ext cx="11377861" cy="3600000"/>
            <a:chOff x="407070" y="1629000"/>
            <a:chExt cx="11377861" cy="36000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841DEDF2-DE00-8A4E-AA4C-5D6FF986092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07070" y="1629000"/>
              <a:ext cx="3600000" cy="360000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B28245A5-7BF9-7648-9FE2-91020327DEA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96000" y="1629000"/>
              <a:ext cx="3600000" cy="36000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DD272FC1-06EB-434E-9F5F-6A6E5F9A3EE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184931" y="1629000"/>
              <a:ext cx="3600000" cy="3600000"/>
            </a:xfrm>
            <a:prstGeom prst="rect">
              <a:avLst/>
            </a:prstGeom>
          </p:spPr>
        </p:pic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4F394B6D-C026-168F-7A02-3BA17940E81F}"/>
              </a:ext>
            </a:extLst>
          </p:cNvPr>
          <p:cNvSpPr txBox="1"/>
          <p:nvPr/>
        </p:nvSpPr>
        <p:spPr>
          <a:xfrm>
            <a:off x="0" y="440976"/>
            <a:ext cx="1219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the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ssue samples </a:t>
            </a:r>
            <a:endParaRPr lang="en-TH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9FCC915-424F-3E3F-8FE4-46E1E88019D0}"/>
              </a:ext>
            </a:extLst>
          </p:cNvPr>
          <p:cNvSpPr txBox="1"/>
          <p:nvPr/>
        </p:nvSpPr>
        <p:spPr>
          <a:xfrm>
            <a:off x="858981" y="5524472"/>
            <a:ext cx="107907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le tissue samples include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he germinal zone of the testis; Tv: testis, part of vas deferens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v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seminal vesicle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male somatic tissues.</a:t>
            </a:r>
            <a:endParaRPr lang="en-TH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54102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4646BF4A-0095-5054-336E-8E3F1F4CF867}"/>
              </a:ext>
            </a:extLst>
          </p:cNvPr>
          <p:cNvGrpSpPr/>
          <p:nvPr/>
        </p:nvGrpSpPr>
        <p:grpSpPr>
          <a:xfrm>
            <a:off x="405063" y="1683825"/>
            <a:ext cx="11381874" cy="3600000"/>
            <a:chOff x="405063" y="1790700"/>
            <a:chExt cx="11381874" cy="36000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7C7D9DCD-A288-7249-B4A0-17EADC722C6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05063" y="1790700"/>
              <a:ext cx="3600000" cy="360000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E0E5C931-3813-A746-9E76-A1367886302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96000" y="1790700"/>
              <a:ext cx="3600000" cy="36000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24405996-E577-9948-95C4-3ABA6BEBB3E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186937" y="1790700"/>
              <a:ext cx="3600000" cy="3600000"/>
            </a:xfrm>
            <a:prstGeom prst="rect">
              <a:avLst/>
            </a:prstGeom>
          </p:spPr>
        </p:pic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C1A99591-302D-3483-7C3E-B6AD010BE6E4}"/>
              </a:ext>
            </a:extLst>
          </p:cNvPr>
          <p:cNvSpPr txBox="1"/>
          <p:nvPr/>
        </p:nvSpPr>
        <p:spPr>
          <a:xfrm>
            <a:off x="0" y="440976"/>
            <a:ext cx="1219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the Tv tissue samples </a:t>
            </a:r>
            <a:endParaRPr lang="en-TH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B666BA4-5005-E472-67EE-D23AA1E2176F}"/>
              </a:ext>
            </a:extLst>
          </p:cNvPr>
          <p:cNvSpPr txBox="1"/>
          <p:nvPr/>
        </p:nvSpPr>
        <p:spPr>
          <a:xfrm>
            <a:off x="858981" y="5524472"/>
            <a:ext cx="107907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le tissue samples include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he germinal zone of the testis; Tv: testis, part of vas deferens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v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seminal vesicle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male somatic tissues.</a:t>
            </a:r>
            <a:endParaRPr lang="en-TH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45276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46D710AB-6AB7-7AD5-7D47-00F518B560A9}"/>
              </a:ext>
            </a:extLst>
          </p:cNvPr>
          <p:cNvGrpSpPr/>
          <p:nvPr/>
        </p:nvGrpSpPr>
        <p:grpSpPr>
          <a:xfrm>
            <a:off x="452120" y="1593375"/>
            <a:ext cx="11287760" cy="3600000"/>
            <a:chOff x="452120" y="1629000"/>
            <a:chExt cx="11287760" cy="36000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F90331DF-1C7F-2C4B-AEC6-771BE4B1FE0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52120" y="1629000"/>
              <a:ext cx="3600000" cy="360000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087835CA-C0C4-DD45-A6E9-1148473BD8E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96000" y="1629000"/>
              <a:ext cx="3600000" cy="36000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6D0149E9-A6D3-5E4B-BD90-3E9C494F47A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139880" y="1629000"/>
              <a:ext cx="3600000" cy="3600000"/>
            </a:xfrm>
            <a:prstGeom prst="rect">
              <a:avLst/>
            </a:prstGeom>
          </p:spPr>
        </p:pic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78F25CA2-D677-0DDF-B8FE-0248C35E5AAB}"/>
              </a:ext>
            </a:extLst>
          </p:cNvPr>
          <p:cNvSpPr txBox="1"/>
          <p:nvPr/>
        </p:nvSpPr>
        <p:spPr>
          <a:xfrm>
            <a:off x="0" y="440976"/>
            <a:ext cx="1219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the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v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ssue samples </a:t>
            </a:r>
            <a:endParaRPr lang="en-TH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72BA3F2-18C6-1208-BE03-60DC4D477C74}"/>
              </a:ext>
            </a:extLst>
          </p:cNvPr>
          <p:cNvSpPr txBox="1"/>
          <p:nvPr/>
        </p:nvSpPr>
        <p:spPr>
          <a:xfrm>
            <a:off x="858981" y="5524472"/>
            <a:ext cx="107907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le tissue samples include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he germinal zone of the testis; Tv: testis, part of vas deferens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v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seminal vesicle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male somatic tissues.</a:t>
            </a:r>
            <a:endParaRPr lang="en-TH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368126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7014D40F-22CB-D2DD-4776-F05DB1909AFB}"/>
              </a:ext>
            </a:extLst>
          </p:cNvPr>
          <p:cNvGrpSpPr/>
          <p:nvPr/>
        </p:nvGrpSpPr>
        <p:grpSpPr>
          <a:xfrm>
            <a:off x="306666" y="1490133"/>
            <a:ext cx="11581759" cy="3600000"/>
            <a:chOff x="211666" y="1490133"/>
            <a:chExt cx="11581759" cy="36000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615CD21D-624D-324F-A059-A7A1D405416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1666" y="1490133"/>
              <a:ext cx="3600000" cy="360000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F22B0D75-FB44-194D-95F2-A304EBD5CA0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02545" y="1490133"/>
              <a:ext cx="3600000" cy="36000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35173C0D-A875-904E-85A9-7DB2E3333A7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193425" y="1490133"/>
              <a:ext cx="3600000" cy="3600000"/>
            </a:xfrm>
            <a:prstGeom prst="rect">
              <a:avLst/>
            </a:prstGeom>
          </p:spPr>
        </p:pic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A4EC3408-CEA7-A01A-E71A-63E0426D5C53}"/>
              </a:ext>
            </a:extLst>
          </p:cNvPr>
          <p:cNvSpPr txBox="1"/>
          <p:nvPr/>
        </p:nvSpPr>
        <p:spPr>
          <a:xfrm>
            <a:off x="0" y="440976"/>
            <a:ext cx="1219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the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m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ssue samples </a:t>
            </a:r>
            <a:endParaRPr lang="en-TH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91B7988-1E7D-DE21-EB3E-5E52652753DD}"/>
              </a:ext>
            </a:extLst>
          </p:cNvPr>
          <p:cNvSpPr txBox="1"/>
          <p:nvPr/>
        </p:nvSpPr>
        <p:spPr>
          <a:xfrm>
            <a:off x="858981" y="5524472"/>
            <a:ext cx="107907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le tissue samples include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he germinal zone of the testis; Tv: testis, part of vas deferens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v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seminal vesicle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male somatic tissues.</a:t>
            </a:r>
            <a:endParaRPr lang="en-TH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9210962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ED1792A4-64AF-B062-ECF4-7D8BF4098463}"/>
              </a:ext>
            </a:extLst>
          </p:cNvPr>
          <p:cNvGrpSpPr/>
          <p:nvPr/>
        </p:nvGrpSpPr>
        <p:grpSpPr>
          <a:xfrm>
            <a:off x="258649" y="1564105"/>
            <a:ext cx="11658200" cy="3600000"/>
            <a:chOff x="104274" y="1564105"/>
            <a:chExt cx="11658200" cy="3600000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DA273ECF-E8D9-3241-81CB-B9591568EDE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4274" y="1564105"/>
              <a:ext cx="3600000" cy="36000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834F0B5C-4F39-2741-8C86-7A20334882B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133374" y="1564105"/>
              <a:ext cx="3600000" cy="360000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648BAB54-0EA0-B44D-8296-770709C0300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162474" y="1564105"/>
              <a:ext cx="3600000" cy="3600000"/>
            </a:xfrm>
            <a:prstGeom prst="rect">
              <a:avLst/>
            </a:prstGeom>
          </p:spPr>
        </p:pic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BAFBDA7B-E4B1-1B77-2A62-D1CE94CDD4F6}"/>
              </a:ext>
            </a:extLst>
          </p:cNvPr>
          <p:cNvSpPr txBox="1"/>
          <p:nvPr/>
        </p:nvSpPr>
        <p:spPr>
          <a:xfrm>
            <a:off x="0" y="440976"/>
            <a:ext cx="1219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the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g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ssue samples </a:t>
            </a:r>
            <a:endParaRPr lang="en-TH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BFA6045-D503-BCE8-874F-488EB1343797}"/>
              </a:ext>
            </a:extLst>
          </p:cNvPr>
          <p:cNvSpPr txBox="1"/>
          <p:nvPr/>
        </p:nvSpPr>
        <p:spPr>
          <a:xfrm>
            <a:off x="858981" y="5524472"/>
            <a:ext cx="107907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male tissue samples include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he germinal zone of the ovary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v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ovary, part of oviduct; Ut: uterus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f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female somatic tissues. </a:t>
            </a:r>
            <a:endParaRPr lang="en-TH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391456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B8641F8-F938-1A20-8BEF-CE05CADDD99F}"/>
              </a:ext>
            </a:extLst>
          </p:cNvPr>
          <p:cNvGrpSpPr/>
          <p:nvPr/>
        </p:nvGrpSpPr>
        <p:grpSpPr>
          <a:xfrm>
            <a:off x="240632" y="1629000"/>
            <a:ext cx="11278238" cy="3600000"/>
            <a:chOff x="240632" y="1629000"/>
            <a:chExt cx="11278238" cy="3600000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C5CC7366-B2DA-6841-89C6-7017D4E1DF0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0632" y="1629000"/>
              <a:ext cx="3600000" cy="360000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0B54B76B-CA97-0946-8C28-364C609C121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079751" y="1629000"/>
              <a:ext cx="3600000" cy="360000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91B7F8D4-2319-E944-99E9-ABADE3936DE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918870" y="1629000"/>
              <a:ext cx="3600000" cy="3600000"/>
            </a:xfrm>
            <a:prstGeom prst="rect">
              <a:avLst/>
            </a:prstGeom>
          </p:spPr>
        </p:pic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65F118D7-D789-61B5-B247-168C51701EC2}"/>
              </a:ext>
            </a:extLst>
          </p:cNvPr>
          <p:cNvSpPr txBox="1"/>
          <p:nvPr/>
        </p:nvSpPr>
        <p:spPr>
          <a:xfrm>
            <a:off x="0" y="440976"/>
            <a:ext cx="1219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between the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v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ssue samples </a:t>
            </a:r>
            <a:endParaRPr lang="en-TH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AC1784B-930D-D265-D9DD-99CB1CB2A523}"/>
              </a:ext>
            </a:extLst>
          </p:cNvPr>
          <p:cNvSpPr txBox="1"/>
          <p:nvPr/>
        </p:nvSpPr>
        <p:spPr>
          <a:xfrm>
            <a:off x="858981" y="5524472"/>
            <a:ext cx="107907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male tissue samples include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he germinal zone of the ovary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v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ovary, part of oviduct; Ut: uterus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f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female somatic tissues. </a:t>
            </a:r>
            <a:endParaRPr lang="en-TH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58450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2</TotalTime>
  <Words>533</Words>
  <Application>Microsoft Macintosh PowerPoint</Application>
  <PresentationFormat>Widescreen</PresentationFormat>
  <Paragraphs>23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rawan Phuphisut</dc:creator>
  <cp:lastModifiedBy>Orawan Phuphisut</cp:lastModifiedBy>
  <cp:revision>22</cp:revision>
  <dcterms:created xsi:type="dcterms:W3CDTF">2022-01-27T09:50:26Z</dcterms:created>
  <dcterms:modified xsi:type="dcterms:W3CDTF">2022-10-23T02:52:23Z</dcterms:modified>
</cp:coreProperties>
</file>